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B6EE1-E4B0-4DBF-BA0C-ADB9FC32A9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8F2D4C-FD12-4D6E-BB01-236D5DFB6E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C7F123-9BD6-4E1C-96BB-882A85B074A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28F1A2-9F40-40FD-B2E3-62FC035232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3475DC-6FC7-4C39-821E-0FBA5E6516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EA8AB3-DDBF-45E7-845E-52AAADBE55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29A82E-13BE-4DD6-8849-026396CB7C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512434-E79F-47C4-BDDB-C2DA0AECE6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1102E6-D8C5-4277-9FA1-762001D679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97E73C-04DE-4E67-88D3-543F2227DA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96500C-D027-4510-951B-34A202450D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D0656C-8C33-47B1-B071-D01E6A1293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CC0CAC4-B911-4D26-9B61-2B27C0421CFF}" type="slidenum">
              <a:rPr b="0" lang="fi-FI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971640" y="1989000"/>
          <a:ext cx="6912000" cy="1766880"/>
        </p:xfrm>
        <a:graphic>
          <a:graphicData uri="http://schemas.openxmlformats.org/drawingml/2006/table">
            <a:tbl>
              <a:tblPr/>
              <a:tblGrid>
                <a:gridCol w="1278000"/>
                <a:gridCol w="595080"/>
                <a:gridCol w="595440"/>
                <a:gridCol w="595440"/>
                <a:gridCol w="595080"/>
                <a:gridCol w="595440"/>
                <a:gridCol w="666720"/>
                <a:gridCol w="666720"/>
                <a:gridCol w="666720"/>
                <a:gridCol w="657360"/>
              </a:tblGrid>
              <a:tr h="405000">
                <a:tc gridSpan="10">
                  <a:txBody>
                    <a:bodyPr lIns="50040" rIns="50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ble S3. Comparison of VP1 protein of MCV and TSV with other polyomavirus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44520">
                <a:tc gridSpan="10"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            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mino acid similarity (in percentage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74480">
                <a:tc>
                  <a:txBody>
                    <a:bodyPr lIns="50040" rIns="50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lyomaviruse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amino-acid length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CV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42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SV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75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J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54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62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I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78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U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69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PyV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87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PyV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80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PyV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71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4160">
                <a:tc>
                  <a:txBody>
                    <a:bodyPr lIns="50040" rIns="50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CV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88720">
                <a:tc>
                  <a:txBody>
                    <a:bodyPr lIns="50040" rIns="50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SV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50040" rIns="50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ctr" pos="2865600"/>
                          <a:tab algn="r" pos="573084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0040" marR="50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2" name="TextBox 4"/>
          <p:cNvSpPr/>
          <p:nvPr/>
        </p:nvSpPr>
        <p:spPr>
          <a:xfrm>
            <a:off x="390960" y="907920"/>
            <a:ext cx="2066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S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1009440" y="3933720"/>
            <a:ext cx="4292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ino acid sequnces were aligned by CLUSTALW2 (EBI-EMBL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6T17:00:43Z</dcterms:created>
  <dc:creator>lab16 arun kumar</dc:creator>
  <dc:description/>
  <dc:language>en-US</dc:language>
  <cp:lastModifiedBy>lab16 arun kumar</cp:lastModifiedBy>
  <dcterms:modified xsi:type="dcterms:W3CDTF">2012-07-06T17:01:24Z</dcterms:modified>
  <cp:revision>1</cp:revision>
  <dc:subject/>
  <dc:title>Slide 1</dc:title>
</cp:coreProperties>
</file>